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4" r:id="rId9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610" y="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D:\2012-2013-2015-2017&#40060;&#19987;&#21033;&#21450;&#25237;&#31295;&#36164;&#26009;&#27719;&#24635;&#65281;\&#40060;-&#19987;&#21033;\2013.12.18Us%20patent-&#22270;&#34920;\&#25991;&#31456;&#30456;&#20851;&#25968;&#25454;&#32479;&#35745;&#22270;&#34920;&#65281;\body%20weight-data%20process.xls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E:\&#31185;&#30740;\&#35770;&#25991;\&#40060;&#33125;&#33609;\&#22823;&#40736;-&#23567;&#40736;&#32954;&#37325;&#25351;&#25968;!%20-7d&#21160;&#29289;&#25968;&#20026;6,&#20197;&#27492;&#20026;&#20934;.xlsx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3837567249795132"/>
          <c:y val="0.1203304167282291"/>
          <c:w val="0.66947068167455204"/>
          <c:h val="0.7528653192346636"/>
        </c:manualLayout>
      </c:layout>
      <c:barChart>
        <c:barDir val="col"/>
        <c:grouping val="clustered"/>
        <c:varyColors val="0"/>
        <c:ser>
          <c:idx val="0"/>
          <c:order val="0"/>
          <c:tx>
            <c:v>Control</c:v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C:\Users\Administrator\Desktop\鱼腥草\[数据图总结.xlsx]Sheet1 (2)'!$B$49,'C:\Users\Administrator\Desktop\鱼腥草\[数据图总结.xlsx]Sheet1 (2)'!$B$54,'C:\Users\Administrator\Desktop\鱼腥草\[数据图总结.xlsx]Sheet1 (2)'!$B$59)</c:f>
                <c:numCache>
                  <c:formatCode>General</c:formatCode>
                  <c:ptCount val="3"/>
                  <c:pt idx="0">
                    <c:v>2.3904572186687871</c:v>
                  </c:pt>
                  <c:pt idx="1">
                    <c:v>3.4948942350643049</c:v>
                  </c:pt>
                  <c:pt idx="2">
                    <c:v>2.2211108331943938</c:v>
                  </c:pt>
                </c:numCache>
              </c:numRef>
            </c:plus>
            <c:minus>
              <c:numRef>
                <c:f>('C:\Users\Administrator\Desktop\鱼腥草\[数据图总结.xlsx]Sheet1 (2)'!$B$49,'C:\Users\Administrator\Desktop\鱼腥草\[数据图总结.xlsx]Sheet1 (2)'!$B$54,'C:\Users\Administrator\Desktop\鱼腥草\[数据图总结.xlsx]Sheet1 (2)'!$B$59)</c:f>
                <c:numCache>
                  <c:formatCode>General</c:formatCode>
                  <c:ptCount val="3"/>
                  <c:pt idx="0">
                    <c:v>2.3904572186687871</c:v>
                  </c:pt>
                  <c:pt idx="1">
                    <c:v>3.4948942350643049</c:v>
                  </c:pt>
                  <c:pt idx="2">
                    <c:v>2.2211108331943938</c:v>
                  </c:pt>
                </c:numCache>
              </c:numRef>
            </c:minus>
          </c:errBars>
          <c:cat>
            <c:strRef>
              <c:f>('C:\Users\Administrator\Desktop\鱼腥草\[数据图总结.xlsx]Sheet1 (2)'!$A$47,'C:\Users\Administrator\Desktop\鱼腥草\[数据图总结.xlsx]Sheet1 (2)'!$A$52,'C:\Users\Administrator\Desktop\鱼腥草\[数据图总结.xlsx]Sheet1 (2)'!$A$57)</c:f>
              <c:strCache>
                <c:ptCount val="3"/>
                <c:pt idx="0">
                  <c:v>7th day</c:v>
                </c:pt>
                <c:pt idx="1">
                  <c:v>14th day</c:v>
                </c:pt>
                <c:pt idx="2">
                  <c:v>28th day</c:v>
                </c:pt>
              </c:strCache>
            </c:strRef>
          </c:cat>
          <c:val>
            <c:numRef>
              <c:f>('C:\Users\Administrator\Desktop\鱼腥草\[数据图总结.xlsx]Sheet1 (2)'!$B$48,'C:\Users\Administrator\Desktop\鱼腥草\[数据图总结.xlsx]Sheet1 (2)'!$B$53,'C:\Users\Administrator\Desktop\鱼腥草\[数据图总结.xlsx]Sheet1 (2)'!$B$58)</c:f>
              <c:numCache>
                <c:formatCode>General</c:formatCode>
                <c:ptCount val="3"/>
                <c:pt idx="0">
                  <c:v>36.5</c:v>
                </c:pt>
                <c:pt idx="1">
                  <c:v>38.75</c:v>
                </c:pt>
                <c:pt idx="2">
                  <c:v>44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213-4F45-AD66-DDC40EF54189}"/>
            </c:ext>
          </c:extLst>
        </c:ser>
        <c:ser>
          <c:idx val="1"/>
          <c:order val="1"/>
          <c:tx>
            <c:v>BLM</c:v>
          </c:tx>
          <c:spPr>
            <a:pattFill prst="ltVert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C:\Users\Administrator\Desktop\鱼腥草\[数据图总结.xlsx]Sheet1 (2)'!$C$49,'C:\Users\Administrator\Desktop\鱼腥草\[数据图总结.xlsx]Sheet1 (2)'!$C$54,'C:\Users\Administrator\Desktop\鱼腥草\[数据图总结.xlsx]Sheet1 (2)'!$C$59)</c:f>
                <c:numCache>
                  <c:formatCode>General</c:formatCode>
                  <c:ptCount val="3"/>
                  <c:pt idx="0">
                    <c:v>1.2817398889233114</c:v>
                  </c:pt>
                  <c:pt idx="1">
                    <c:v>0.7559289460184544</c:v>
                  </c:pt>
                  <c:pt idx="2">
                    <c:v>3.2249030993193948</c:v>
                  </c:pt>
                </c:numCache>
              </c:numRef>
            </c:plus>
            <c:minus>
              <c:numRef>
                <c:f>('C:\Users\Administrator\Desktop\鱼腥草\[数据图总结.xlsx]Sheet1 (2)'!$C$49,'C:\Users\Administrator\Desktop\鱼腥草\[数据图总结.xlsx]Sheet1 (2)'!$C$54,'C:\Users\Administrator\Desktop\鱼腥草\[数据图总结.xlsx]Sheet1 (2)'!$C$59)</c:f>
                <c:numCache>
                  <c:formatCode>General</c:formatCode>
                  <c:ptCount val="3"/>
                  <c:pt idx="0">
                    <c:v>1.2817398889233114</c:v>
                  </c:pt>
                  <c:pt idx="1">
                    <c:v>0.7559289460184544</c:v>
                  </c:pt>
                  <c:pt idx="2">
                    <c:v>3.2249030993193948</c:v>
                  </c:pt>
                </c:numCache>
              </c:numRef>
            </c:minus>
          </c:errBars>
          <c:cat>
            <c:strRef>
              <c:f>('C:\Users\Administrator\Desktop\鱼腥草\[数据图总结.xlsx]Sheet1 (2)'!$A$47,'C:\Users\Administrator\Desktop\鱼腥草\[数据图总结.xlsx]Sheet1 (2)'!$A$52,'C:\Users\Administrator\Desktop\鱼腥草\[数据图总结.xlsx]Sheet1 (2)'!$A$57)</c:f>
              <c:strCache>
                <c:ptCount val="3"/>
                <c:pt idx="0">
                  <c:v>7th day</c:v>
                </c:pt>
                <c:pt idx="1">
                  <c:v>14th day</c:v>
                </c:pt>
                <c:pt idx="2">
                  <c:v>28th day</c:v>
                </c:pt>
              </c:strCache>
            </c:strRef>
          </c:cat>
          <c:val>
            <c:numRef>
              <c:f>('C:\Users\Administrator\Desktop\鱼腥草\[数据图总结.xlsx]Sheet1 (2)'!$C$48,'C:\Users\Administrator\Desktop\鱼腥草\[数据图总结.xlsx]Sheet1 (2)'!$C$53,'C:\Users\Administrator\Desktop\鱼腥草\[数据图总结.xlsx]Sheet1 (2)'!$C$58)</c:f>
              <c:numCache>
                <c:formatCode>General</c:formatCode>
                <c:ptCount val="3"/>
                <c:pt idx="0">
                  <c:v>35.25</c:v>
                </c:pt>
                <c:pt idx="1">
                  <c:v>40</c:v>
                </c:pt>
                <c:pt idx="2">
                  <c:v>42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213-4F45-AD66-DDC40EF54189}"/>
            </c:ext>
          </c:extLst>
        </c:ser>
        <c:ser>
          <c:idx val="2"/>
          <c:order val="2"/>
          <c:tx>
            <c:v>BLM+PA</c:v>
          </c:tx>
          <c:spPr>
            <a:pattFill prst="pct25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C:\Users\Administrator\Desktop\鱼腥草\[数据图总结.xlsx]Sheet1 (2)'!$D$49,'C:\Users\Administrator\Desktop\鱼腥草\[数据图总结.xlsx]Sheet1 (2)'!$D$54,'C:\Users\Administrator\Desktop\鱼腥草\[数据图总结.xlsx]Sheet1 (2)'!$D$59)</c:f>
                <c:numCache>
                  <c:formatCode>General</c:formatCode>
                  <c:ptCount val="3"/>
                  <c:pt idx="0">
                    <c:v>1.6035674514745464</c:v>
                  </c:pt>
                  <c:pt idx="1">
                    <c:v>2.4748737341529163</c:v>
                  </c:pt>
                  <c:pt idx="2">
                    <c:v>4.1109609582188984</c:v>
                  </c:pt>
                </c:numCache>
              </c:numRef>
            </c:plus>
            <c:minus>
              <c:numRef>
                <c:f>('C:\Users\Administrator\Desktop\鱼腥草\[数据图总结.xlsx]Sheet1 (2)'!$D$49,'C:\Users\Administrator\Desktop\鱼腥草\[数据图总结.xlsx]Sheet1 (2)'!$D$54,'C:\Users\Administrator\Desktop\鱼腥草\[数据图总结.xlsx]Sheet1 (2)'!$D$59)</c:f>
                <c:numCache>
                  <c:formatCode>General</c:formatCode>
                  <c:ptCount val="3"/>
                  <c:pt idx="0">
                    <c:v>1.6035674514745464</c:v>
                  </c:pt>
                  <c:pt idx="1">
                    <c:v>2.4748737341529163</c:v>
                  </c:pt>
                  <c:pt idx="2">
                    <c:v>4.1109609582188984</c:v>
                  </c:pt>
                </c:numCache>
              </c:numRef>
            </c:minus>
          </c:errBars>
          <c:cat>
            <c:strRef>
              <c:f>('C:\Users\Administrator\Desktop\鱼腥草\[数据图总结.xlsx]Sheet1 (2)'!$A$47,'C:\Users\Administrator\Desktop\鱼腥草\[数据图总结.xlsx]Sheet1 (2)'!$A$52,'C:\Users\Administrator\Desktop\鱼腥草\[数据图总结.xlsx]Sheet1 (2)'!$A$57)</c:f>
              <c:strCache>
                <c:ptCount val="3"/>
                <c:pt idx="0">
                  <c:v>7th day</c:v>
                </c:pt>
                <c:pt idx="1">
                  <c:v>14th day</c:v>
                </c:pt>
                <c:pt idx="2">
                  <c:v>28th day</c:v>
                </c:pt>
              </c:strCache>
            </c:strRef>
          </c:cat>
          <c:val>
            <c:numRef>
              <c:f>('C:\Users\Administrator\Desktop\鱼腥草\[数据图总结.xlsx]Sheet1 (2)'!$D$48,'C:\Users\Administrator\Desktop\鱼腥草\[数据图总结.xlsx]Sheet1 (2)'!$D$53,'C:\Users\Administrator\Desktop\鱼腥草\[数据图总结.xlsx]Sheet1 (2)'!$D$58)</c:f>
              <c:numCache>
                <c:formatCode>General</c:formatCode>
                <c:ptCount val="3"/>
                <c:pt idx="0">
                  <c:v>30</c:v>
                </c:pt>
                <c:pt idx="1">
                  <c:v>35.875</c:v>
                </c:pt>
                <c:pt idx="2">
                  <c:v>38.29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213-4F45-AD66-DDC40EF54189}"/>
            </c:ext>
          </c:extLst>
        </c:ser>
        <c:ser>
          <c:idx val="3"/>
          <c:order val="3"/>
          <c:tx>
            <c:v>BLM+SH High</c:v>
          </c:tx>
          <c:spPr>
            <a:pattFill prst="lgCheck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C:\Users\Administrator\Desktop\鱼腥草\[数据图总结.xlsx]Sheet1 (2)'!$E$49,'C:\Users\Administrator\Desktop\鱼腥草\[数据图总结.xlsx]Sheet1 (2)'!$E$54,'C:\Users\Administrator\Desktop\鱼腥草\[数据图总结.xlsx]Sheet1 (2)'!$E$59)</c:f>
                <c:numCache>
                  <c:formatCode>General</c:formatCode>
                  <c:ptCount val="3"/>
                  <c:pt idx="0">
                    <c:v>4.4860896112315904</c:v>
                  </c:pt>
                  <c:pt idx="1">
                    <c:v>1.4880476182856899</c:v>
                  </c:pt>
                  <c:pt idx="2">
                    <c:v>3.0110906108363307</c:v>
                  </c:pt>
                </c:numCache>
              </c:numRef>
            </c:plus>
            <c:minus>
              <c:numRef>
                <c:f>('C:\Users\Administrator\Desktop\鱼腥草\[数据图总结.xlsx]Sheet1 (2)'!$E$49,'C:\Users\Administrator\Desktop\鱼腥草\[数据图总结.xlsx]Sheet1 (2)'!$E$54,'C:\Users\Administrator\Desktop\鱼腥草\[数据图总结.xlsx]Sheet1 (2)'!$E$59)</c:f>
                <c:numCache>
                  <c:formatCode>General</c:formatCode>
                  <c:ptCount val="3"/>
                  <c:pt idx="0">
                    <c:v>4.4860896112315904</c:v>
                  </c:pt>
                  <c:pt idx="1">
                    <c:v>1.4880476182856899</c:v>
                  </c:pt>
                  <c:pt idx="2">
                    <c:v>3.0110906108363307</c:v>
                  </c:pt>
                </c:numCache>
              </c:numRef>
            </c:minus>
          </c:errBars>
          <c:cat>
            <c:strRef>
              <c:f>('C:\Users\Administrator\Desktop\鱼腥草\[数据图总结.xlsx]Sheet1 (2)'!$A$47,'C:\Users\Administrator\Desktop\鱼腥草\[数据图总结.xlsx]Sheet1 (2)'!$A$52,'C:\Users\Administrator\Desktop\鱼腥草\[数据图总结.xlsx]Sheet1 (2)'!$A$57)</c:f>
              <c:strCache>
                <c:ptCount val="3"/>
                <c:pt idx="0">
                  <c:v>7th day</c:v>
                </c:pt>
                <c:pt idx="1">
                  <c:v>14th day</c:v>
                </c:pt>
                <c:pt idx="2">
                  <c:v>28th day</c:v>
                </c:pt>
              </c:strCache>
            </c:strRef>
          </c:cat>
          <c:val>
            <c:numRef>
              <c:f>('C:\Users\Administrator\Desktop\鱼腥草\[数据图总结.xlsx]Sheet1 (2)'!$E$48,'C:\Users\Administrator\Desktop\鱼腥草\[数据图总结.xlsx]Sheet1 (2)'!$E$53,'C:\Users\Administrator\Desktop\鱼腥草\[数据图总结.xlsx]Sheet1 (2)'!$E$58)</c:f>
              <c:numCache>
                <c:formatCode>General</c:formatCode>
                <c:ptCount val="3"/>
                <c:pt idx="0">
                  <c:v>33.125</c:v>
                </c:pt>
                <c:pt idx="1">
                  <c:v>39.25</c:v>
                </c:pt>
                <c:pt idx="2">
                  <c:v>40.20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213-4F45-AD66-DDC40EF54189}"/>
            </c:ext>
          </c:extLst>
        </c:ser>
        <c:ser>
          <c:idx val="4"/>
          <c:order val="4"/>
          <c:tx>
            <c:v>BLM+SH Low</c:v>
          </c:tx>
          <c:spPr>
            <a:pattFill prst="divot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C:\Users\Administrator\Desktop\鱼腥草\[数据图总结.xlsx]Sheet1 (2)'!$F$49,'C:\Users\Administrator\Desktop\鱼腥草\[数据图总结.xlsx]Sheet1 (2)'!$F$54,'C:\Users\Administrator\Desktop\鱼腥草\[数据图总结.xlsx]Sheet1 (2)'!$F$59)</c:f>
                <c:numCache>
                  <c:formatCode>General</c:formatCode>
                  <c:ptCount val="3"/>
                  <c:pt idx="0">
                    <c:v>2.0310096011589902</c:v>
                  </c:pt>
                  <c:pt idx="1">
                    <c:v>5.391792704790177</c:v>
                  </c:pt>
                  <c:pt idx="2">
                    <c:v>2.2236106773543889</c:v>
                  </c:pt>
                </c:numCache>
              </c:numRef>
            </c:plus>
            <c:minus>
              <c:numRef>
                <c:f>('C:\Users\Administrator\Desktop\鱼腥草\[数据图总结.xlsx]Sheet1 (2)'!$F$49,'C:\Users\Administrator\Desktop\鱼腥草\[数据图总结.xlsx]Sheet1 (2)'!$F$54,'C:\Users\Administrator\Desktop\鱼腥草\[数据图总结.xlsx]Sheet1 (2)'!$F$59)</c:f>
                <c:numCache>
                  <c:formatCode>General</c:formatCode>
                  <c:ptCount val="3"/>
                  <c:pt idx="0">
                    <c:v>2.0310096011589902</c:v>
                  </c:pt>
                  <c:pt idx="1">
                    <c:v>5.391792704790177</c:v>
                  </c:pt>
                  <c:pt idx="2">
                    <c:v>2.2236106773543889</c:v>
                  </c:pt>
                </c:numCache>
              </c:numRef>
            </c:minus>
          </c:errBars>
          <c:cat>
            <c:strRef>
              <c:f>('C:\Users\Administrator\Desktop\鱼腥草\[数据图总结.xlsx]Sheet1 (2)'!$A$47,'C:\Users\Administrator\Desktop\鱼腥草\[数据图总结.xlsx]Sheet1 (2)'!$A$52,'C:\Users\Administrator\Desktop\鱼腥草\[数据图总结.xlsx]Sheet1 (2)'!$A$57)</c:f>
              <c:strCache>
                <c:ptCount val="3"/>
                <c:pt idx="0">
                  <c:v>7th day</c:v>
                </c:pt>
                <c:pt idx="1">
                  <c:v>14th day</c:v>
                </c:pt>
                <c:pt idx="2">
                  <c:v>28th day</c:v>
                </c:pt>
              </c:strCache>
            </c:strRef>
          </c:cat>
          <c:val>
            <c:numRef>
              <c:f>('C:\Users\Administrator\Desktop\鱼腥草\[数据图总结.xlsx]Sheet1 (2)'!$F$48,'C:\Users\Administrator\Desktop\鱼腥草\[数据图总结.xlsx]Sheet1 (2)'!$F$53,'C:\Users\Administrator\Desktop\鱼腥草\[数据图总结.xlsx]Sheet1 (2)'!$F$58)</c:f>
              <c:numCache>
                <c:formatCode>General</c:formatCode>
                <c:ptCount val="3"/>
                <c:pt idx="0">
                  <c:v>34.125</c:v>
                </c:pt>
                <c:pt idx="1">
                  <c:v>40.25</c:v>
                </c:pt>
                <c:pt idx="2">
                  <c:v>39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213-4F45-AD66-DDC40EF541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5937024"/>
        <c:axId val="215938944"/>
      </c:barChart>
      <c:catAx>
        <c:axId val="2159370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38100">
            <a:solidFill>
              <a:schemeClr val="tx1"/>
            </a:solidFill>
          </a:ln>
        </c:spPr>
        <c:txPr>
          <a:bodyPr/>
          <a:lstStyle/>
          <a:p>
            <a:pPr>
              <a:defRPr sz="1900" b="1" i="0"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zh-CN"/>
          </a:p>
        </c:txPr>
        <c:crossAx val="215938944"/>
        <c:crosses val="autoZero"/>
        <c:auto val="1"/>
        <c:lblAlgn val="ctr"/>
        <c:lblOffset val="100"/>
        <c:noMultiLvlLbl val="0"/>
      </c:catAx>
      <c:valAx>
        <c:axId val="21593894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20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altLang="zh-CN" sz="2000">
                    <a:latin typeface="Times New Roman" pitchFamily="18" charset="0"/>
                    <a:cs typeface="Times New Roman" pitchFamily="18" charset="0"/>
                  </a:rPr>
                  <a:t>Body</a:t>
                </a:r>
                <a:r>
                  <a:rPr lang="en-US" altLang="zh-CN" sz="2000" baseline="0">
                    <a:latin typeface="Times New Roman" pitchFamily="18" charset="0"/>
                    <a:cs typeface="Times New Roman" pitchFamily="18" charset="0"/>
                  </a:rPr>
                  <a:t> Weight (g)</a:t>
                </a:r>
                <a:endParaRPr lang="zh-CN" altLang="en-US" sz="2000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>
            <c:manualLayout>
              <c:xMode val="edge"/>
              <c:yMode val="edge"/>
              <c:x val="2.2751977044084239E-2"/>
              <c:y val="0.3254495796763322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38100">
            <a:solidFill>
              <a:schemeClr val="tx1"/>
            </a:solidFill>
          </a:ln>
        </c:spPr>
        <c:txPr>
          <a:bodyPr/>
          <a:lstStyle/>
          <a:p>
            <a:pPr>
              <a:defRPr sz="2000" b="1" i="0"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zh-CN"/>
          </a:p>
        </c:txPr>
        <c:crossAx val="21593702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1833683479369856"/>
          <c:y val="0.25929709080177749"/>
          <c:w val="0.17298637561844898"/>
          <c:h val="0.40014321263994063"/>
        </c:manualLayout>
      </c:layout>
      <c:overlay val="0"/>
      <c:txPr>
        <a:bodyPr/>
        <a:lstStyle/>
        <a:p>
          <a:pPr>
            <a:defRPr sz="1500" b="1" i="0" baseline="0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6738246783089897"/>
          <c:y val="0.15957893567381401"/>
          <c:w val="0.64499237425476663"/>
          <c:h val="0.7292559057224093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小鼠肺重指数!$B$50</c:f>
              <c:strCache>
                <c:ptCount val="1"/>
                <c:pt idx="0">
                  <c:v>SH</c:v>
                </c:pt>
              </c:strCache>
            </c:strRef>
          </c:tx>
          <c:spPr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>
                  <a:alpha val="95000"/>
                </a:schemeClr>
              </a:solidFill>
            </a:ln>
            <a:effectLst/>
          </c:spPr>
          <c:invertIfNegative val="0"/>
          <c:cat>
            <c:strRef>
              <c:f>小鼠肺重指数!$A$50</c:f>
              <c:strCache>
                <c:ptCount val="1"/>
                <c:pt idx="0">
                  <c:v>28th day</c:v>
                </c:pt>
              </c:strCache>
            </c:strRef>
          </c:cat>
          <c:val>
            <c:numRef>
              <c:f>小鼠肺重指数!$B$51:$B$53</c:f>
              <c:numCache>
                <c:formatCode>General</c:formatCode>
                <c:ptCount val="1"/>
                <c:pt idx="0">
                  <c:v>0.484008309978428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5FB-40B5-AA0C-DCD72B37F8F2}"/>
            </c:ext>
          </c:extLst>
        </c:ser>
        <c:ser>
          <c:idx val="1"/>
          <c:order val="1"/>
          <c:tx>
            <c:strRef>
              <c:f>小鼠肺重指数!$C$50</c:f>
              <c:strCache>
                <c:ptCount val="1"/>
                <c:pt idx="0">
                  <c:v>Control</c:v>
                </c:pt>
              </c:strCache>
            </c:strRef>
          </c:tx>
          <c:spPr>
            <a:pattFill prst="lgCheck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小鼠肺重指数!$A$50</c:f>
              <c:strCache>
                <c:ptCount val="1"/>
                <c:pt idx="0">
                  <c:v>28th day</c:v>
                </c:pt>
              </c:strCache>
            </c:strRef>
          </c:cat>
          <c:val>
            <c:numRef>
              <c:f>小鼠肺重指数!$C$51:$C$53</c:f>
              <c:numCache>
                <c:formatCode>General</c:formatCode>
                <c:ptCount val="1"/>
                <c:pt idx="0">
                  <c:v>0.473888694131634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5FB-40B5-AA0C-DCD72B37F8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16"/>
        <c:overlap val="-40"/>
        <c:axId val="228445184"/>
        <c:axId val="229546624"/>
      </c:barChart>
      <c:catAx>
        <c:axId val="228445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29546624"/>
        <c:crosses val="autoZero"/>
        <c:auto val="1"/>
        <c:lblAlgn val="ctr"/>
        <c:lblOffset val="100"/>
        <c:noMultiLvlLbl val="0"/>
      </c:catAx>
      <c:valAx>
        <c:axId val="229546624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4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2400" dirty="0">
                    <a:effectLst/>
                  </a:rPr>
                  <a:t>PI(PW/BW*100)</a:t>
                </a:r>
                <a:endParaRPr lang="zh-CN" altLang="zh-CN" sz="24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2.2046164726801872E-2"/>
              <c:y val="0.2934972245882144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381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28445184"/>
        <c:crosses val="autoZero"/>
        <c:crossBetween val="between"/>
        <c:majorUnit val="0.2"/>
        <c:minorUnit val="1.0000000000000002E-2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7027795092760976"/>
          <c:y val="0.35863573457544495"/>
          <c:w val="0.21869896670898933"/>
          <c:h val="0.2021647800450155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1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1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1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1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图片 0" descr="SH structure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7624" y="2636912"/>
            <a:ext cx="6696744" cy="23824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611560" y="692696"/>
            <a:ext cx="75608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Supplementary Figure S1:</a:t>
            </a:r>
            <a:r>
              <a:rPr lang="en-US" altLang="zh-CN" dirty="0"/>
              <a:t> Structure of sodium </a:t>
            </a:r>
            <a:r>
              <a:rPr lang="en-US" altLang="zh-CN" dirty="0" err="1"/>
              <a:t>houttuyfonate</a:t>
            </a:r>
            <a:r>
              <a:rPr lang="en-US" altLang="zh-CN" dirty="0"/>
              <a:t>.</a:t>
            </a:r>
            <a:endParaRPr lang="zh-CN" altLang="zh-CN" dirty="0"/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344714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02011686"/>
              </p:ext>
            </p:extLst>
          </p:nvPr>
        </p:nvGraphicFramePr>
        <p:xfrm>
          <a:off x="180975" y="980728"/>
          <a:ext cx="8782050" cy="54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259632" y="476672"/>
            <a:ext cx="727280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Supplementary Figure S2: </a:t>
            </a:r>
            <a:r>
              <a:rPr lang="en-US" altLang="zh-CN" dirty="0"/>
              <a:t>Effect of SH on body weight in BLM mice. Each bar represents the </a:t>
            </a:r>
            <a:r>
              <a:rPr lang="en-US" altLang="zh-CN" dirty="0" err="1"/>
              <a:t>mean±SD</a:t>
            </a:r>
            <a:r>
              <a:rPr lang="en-US" altLang="zh-CN" dirty="0"/>
              <a:t> in each group (</a:t>
            </a:r>
            <a:r>
              <a:rPr lang="en-US" altLang="zh-CN" i="1" dirty="0"/>
              <a:t>n</a:t>
            </a:r>
            <a:r>
              <a:rPr lang="en-US" altLang="zh-CN" dirty="0"/>
              <a:t>=6~10).</a:t>
            </a:r>
            <a:endParaRPr lang="zh-CN" altLang="zh-CN" dirty="0"/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444003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>
            <a:extLst>
              <a:ext uri="{FF2B5EF4-FFF2-40B4-BE49-F238E27FC236}">
                <a16:creationId xmlns:a16="http://schemas.microsoft.com/office/drawing/2014/main" id="{1AAAEA9D-A421-44E9-B878-4F25D87FCB9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79104721"/>
              </p:ext>
            </p:extLst>
          </p:nvPr>
        </p:nvGraphicFramePr>
        <p:xfrm>
          <a:off x="683568" y="764704"/>
          <a:ext cx="6912767" cy="58326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4A0D96FB-0049-45BB-B888-F8C1C44DA016}"/>
              </a:ext>
            </a:extLst>
          </p:cNvPr>
          <p:cNvSpPr txBox="1"/>
          <p:nvPr/>
        </p:nvSpPr>
        <p:spPr>
          <a:xfrm>
            <a:off x="5004048" y="6093296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47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797E4D71-E726-4A2A-AAD9-E3C47388732B}"/>
              </a:ext>
            </a:extLst>
          </p:cNvPr>
          <p:cNvSpPr txBox="1"/>
          <p:nvPr/>
        </p:nvSpPr>
        <p:spPr>
          <a:xfrm>
            <a:off x="814196" y="476672"/>
            <a:ext cx="83298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Supplementary Figure S3:</a:t>
            </a:r>
            <a:r>
              <a:rPr lang="en-US" altLang="zh-CN" dirty="0"/>
              <a:t> Effect of SH on lung/body weight ratio in Control mice and SH treated alone mice. Each bar represents the mean ± SD in each group (</a:t>
            </a:r>
            <a:r>
              <a:rPr lang="en-US" altLang="zh-CN" i="1" dirty="0"/>
              <a:t>n </a:t>
            </a:r>
            <a:r>
              <a:rPr lang="en-US" altLang="zh-CN" dirty="0"/>
              <a:t>= 10). </a:t>
            </a:r>
            <a:endParaRPr lang="zh-CN" altLang="zh-CN" dirty="0"/>
          </a:p>
        </p:txBody>
      </p:sp>
    </p:spTree>
    <p:extLst>
      <p:ext uri="{BB962C8B-B14F-4D97-AF65-F5344CB8AC3E}">
        <p14:creationId xmlns:p14="http://schemas.microsoft.com/office/powerpoint/2010/main" val="37829101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0108D55F-8126-4E94-B19D-8A3D14FFDE6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5576" y="440735"/>
            <a:ext cx="3995936" cy="298826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3CFEEE82-72EA-418C-9CB7-71D9A4ACE0F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1512" y="3457670"/>
            <a:ext cx="4283131" cy="3203037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E5067C3C-B9A3-4CBF-92F0-6FF870B1786E}"/>
              </a:ext>
            </a:extLst>
          </p:cNvPr>
          <p:cNvSpPr txBox="1"/>
          <p:nvPr/>
        </p:nvSpPr>
        <p:spPr>
          <a:xfrm>
            <a:off x="395536" y="4182025"/>
            <a:ext cx="410445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Supplementary Figure S4: </a:t>
            </a:r>
            <a:r>
              <a:rPr lang="en-US" altLang="zh-CN" dirty="0"/>
              <a:t>Lung tissue morphological changes in SH treated alone mice (H&amp;E staining, x200 magnification). Samples were collected at 28th day after SH treated alone.</a:t>
            </a:r>
            <a:endParaRPr lang="zh-CN" altLang="zh-CN" dirty="0"/>
          </a:p>
        </p:txBody>
      </p:sp>
    </p:spTree>
    <p:extLst>
      <p:ext uri="{BB962C8B-B14F-4D97-AF65-F5344CB8AC3E}">
        <p14:creationId xmlns:p14="http://schemas.microsoft.com/office/powerpoint/2010/main" val="5185298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G:\科研\论文\鱼腥草\师姐给的资料\20200621师姐的资料\2013-10-30Psmad\2013-10-30Psmad\2013-11-01-PSmad\2013-11-02G2-1_2_16bit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544" y="447674"/>
            <a:ext cx="4148815" cy="31253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G:\科研\论文\鱼腥草\师姐给的资料\20200621师姐的资料\2013-10-30Psmad\2013-10-30Psmad\2013-11-01-PSmad\2013-11-02G2-1_8bit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4169" y="447675"/>
            <a:ext cx="4148815" cy="34853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452836" y="5085184"/>
            <a:ext cx="678346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/>
              <a:t>Supplementary Figure S5A: </a:t>
            </a:r>
            <a:r>
              <a:rPr lang="en-US" altLang="zh-CN" sz="3200" dirty="0"/>
              <a:t>Full-gel images of pSmad2/3</a:t>
            </a:r>
            <a:endParaRPr lang="zh-CN" altLang="zh-CN" sz="3200" dirty="0"/>
          </a:p>
        </p:txBody>
      </p:sp>
    </p:spTree>
    <p:extLst>
      <p:ext uri="{BB962C8B-B14F-4D97-AF65-F5344CB8AC3E}">
        <p14:creationId xmlns:p14="http://schemas.microsoft.com/office/powerpoint/2010/main" val="1321291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6" name="Picture 4" descr="G:\科研\论文\鱼腥草\师姐给的资料\20200621师姐的资料\2013-10-30TGF\2013-11-01_15-49-11T\2013-11-01_15-49-11T_8bit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362" y="809040"/>
            <a:ext cx="7915275" cy="55016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79512" y="260648"/>
            <a:ext cx="756084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Supplementary Figure S5B:</a:t>
            </a:r>
            <a:r>
              <a:rPr lang="en-US" altLang="zh-CN" sz="2400" dirty="0"/>
              <a:t> Full-gel images of TGF-β1</a:t>
            </a:r>
            <a:endParaRPr lang="zh-CN" altLang="zh-CN" sz="2400" dirty="0"/>
          </a:p>
          <a:p>
            <a:endParaRPr lang="zh-CN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98681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E73995D7-FAE4-4ECF-93CE-1DC837BA2DE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93" t="29702" r="28136" b="30193"/>
          <a:stretch/>
        </p:blipFill>
        <p:spPr>
          <a:xfrm>
            <a:off x="899592" y="620688"/>
            <a:ext cx="7493068" cy="4392488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CF803FE9-62F7-49B4-B60A-7A8BC548CA0D}"/>
              </a:ext>
            </a:extLst>
          </p:cNvPr>
          <p:cNvSpPr txBox="1"/>
          <p:nvPr/>
        </p:nvSpPr>
        <p:spPr>
          <a:xfrm>
            <a:off x="395536" y="5229200"/>
            <a:ext cx="73448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Supplementary Figure S5C:</a:t>
            </a:r>
            <a:r>
              <a:rPr lang="en-US" altLang="zh-CN" sz="2400" dirty="0"/>
              <a:t> Full-gel images of GAPDH</a:t>
            </a:r>
            <a:endParaRPr lang="zh-CN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092379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文本框 19">
            <a:extLst>
              <a:ext uri="{FF2B5EF4-FFF2-40B4-BE49-F238E27FC236}">
                <a16:creationId xmlns:a16="http://schemas.microsoft.com/office/drawing/2014/main" id="{1ADED8EF-0B15-44DC-B98B-B453BB4E570D}"/>
              </a:ext>
            </a:extLst>
          </p:cNvPr>
          <p:cNvSpPr txBox="1"/>
          <p:nvPr/>
        </p:nvSpPr>
        <p:spPr>
          <a:xfrm>
            <a:off x="971553" y="3425233"/>
            <a:ext cx="55447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0</a:t>
            </a:r>
            <a:endParaRPr lang="zh-CN" altLang="en-US" sz="13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509261BD-9D57-4C57-9C35-FADFED28CDD2}"/>
              </a:ext>
            </a:extLst>
          </p:cNvPr>
          <p:cNvSpPr txBox="1"/>
          <p:nvPr/>
        </p:nvSpPr>
        <p:spPr>
          <a:xfrm>
            <a:off x="744143" y="1889329"/>
            <a:ext cx="1427555" cy="50783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zh-CN" sz="1350" kern="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i.t.</a:t>
            </a:r>
            <a:r>
              <a:rPr lang="en-US" altLang="zh-CN" sz="1350" kern="0" dirty="0">
                <a:solidFill>
                  <a:srgbClr val="000000"/>
                </a:solidFill>
                <a:latin typeface="Times New Roman" panose="02020603050405020304" pitchFamily="18" charset="0"/>
                <a:ea typeface="TimesNewRomanPS"/>
              </a:rPr>
              <a:t> </a:t>
            </a:r>
            <a:r>
              <a:rPr lang="en-US" altLang="zh-CN" sz="1350" kern="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BLM 96 mice </a:t>
            </a:r>
          </a:p>
          <a:p>
            <a:r>
              <a:rPr lang="en-US" altLang="zh-CN" sz="1350" kern="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i.t. NS. 24 mice </a:t>
            </a:r>
            <a:endParaRPr lang="zh-CN" altLang="en-US" sz="1350" dirty="0"/>
          </a:p>
        </p:txBody>
      </p:sp>
      <p:sp>
        <p:nvSpPr>
          <p:cNvPr id="24" name="箭头: 下 23">
            <a:extLst>
              <a:ext uri="{FF2B5EF4-FFF2-40B4-BE49-F238E27FC236}">
                <a16:creationId xmlns:a16="http://schemas.microsoft.com/office/drawing/2014/main" id="{95B10D4B-96AE-430F-9D31-7534BFE7CD4A}"/>
              </a:ext>
            </a:extLst>
          </p:cNvPr>
          <p:cNvSpPr/>
          <p:nvPr/>
        </p:nvSpPr>
        <p:spPr>
          <a:xfrm>
            <a:off x="1273100" y="2611459"/>
            <a:ext cx="138607" cy="284534"/>
          </a:xfrm>
          <a:prstGeom prst="downArrow">
            <a:avLst/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20B32B29-4284-49D4-AC62-1E22B5567B65}"/>
              </a:ext>
            </a:extLst>
          </p:cNvPr>
          <p:cNvSpPr txBox="1"/>
          <p:nvPr/>
        </p:nvSpPr>
        <p:spPr>
          <a:xfrm>
            <a:off x="2682406" y="3454774"/>
            <a:ext cx="55447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7</a:t>
            </a:r>
            <a:endParaRPr lang="zh-CN" altLang="en-US" sz="13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F6D3E2C-3623-474E-8327-67DC89F4F458}"/>
              </a:ext>
            </a:extLst>
          </p:cNvPr>
          <p:cNvSpPr txBox="1"/>
          <p:nvPr/>
        </p:nvSpPr>
        <p:spPr>
          <a:xfrm>
            <a:off x="4274095" y="3454774"/>
            <a:ext cx="595811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14</a:t>
            </a:r>
            <a:endParaRPr lang="zh-CN" altLang="en-US" sz="13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F3F30E02-A96D-4C73-BF02-CBE8BFAE0A55}"/>
              </a:ext>
            </a:extLst>
          </p:cNvPr>
          <p:cNvSpPr txBox="1"/>
          <p:nvPr/>
        </p:nvSpPr>
        <p:spPr>
          <a:xfrm>
            <a:off x="5915638" y="3425233"/>
            <a:ext cx="595811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28</a:t>
            </a:r>
            <a:endParaRPr lang="zh-CN" altLang="en-US" sz="13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箭头: 下 28">
            <a:extLst>
              <a:ext uri="{FF2B5EF4-FFF2-40B4-BE49-F238E27FC236}">
                <a16:creationId xmlns:a16="http://schemas.microsoft.com/office/drawing/2014/main" id="{10F68483-A0BB-466F-AD96-4E3521FC84E9}"/>
              </a:ext>
            </a:extLst>
          </p:cNvPr>
          <p:cNvSpPr/>
          <p:nvPr/>
        </p:nvSpPr>
        <p:spPr>
          <a:xfrm>
            <a:off x="2890337" y="2611458"/>
            <a:ext cx="138607" cy="284534"/>
          </a:xfrm>
          <a:prstGeom prst="downArrow">
            <a:avLst/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  <p:sp>
        <p:nvSpPr>
          <p:cNvPr id="30" name="箭头: 下 29">
            <a:extLst>
              <a:ext uri="{FF2B5EF4-FFF2-40B4-BE49-F238E27FC236}">
                <a16:creationId xmlns:a16="http://schemas.microsoft.com/office/drawing/2014/main" id="{C4FFA76F-2183-46FC-8558-98BAAC4507DE}"/>
              </a:ext>
            </a:extLst>
          </p:cNvPr>
          <p:cNvSpPr/>
          <p:nvPr/>
        </p:nvSpPr>
        <p:spPr>
          <a:xfrm>
            <a:off x="4520936" y="2600392"/>
            <a:ext cx="138607" cy="284534"/>
          </a:xfrm>
          <a:prstGeom prst="downArrow">
            <a:avLst/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  <p:sp>
        <p:nvSpPr>
          <p:cNvPr id="31" name="箭头: 下 30">
            <a:extLst>
              <a:ext uri="{FF2B5EF4-FFF2-40B4-BE49-F238E27FC236}">
                <a16:creationId xmlns:a16="http://schemas.microsoft.com/office/drawing/2014/main" id="{898F2441-BC8D-4D4E-8820-F47A5F80041A}"/>
              </a:ext>
            </a:extLst>
          </p:cNvPr>
          <p:cNvSpPr/>
          <p:nvPr/>
        </p:nvSpPr>
        <p:spPr>
          <a:xfrm>
            <a:off x="6151536" y="2611456"/>
            <a:ext cx="138607" cy="284534"/>
          </a:xfrm>
          <a:prstGeom prst="downArrow">
            <a:avLst/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75B9D255-AD77-45D3-81E4-383A6E60E3D5}"/>
              </a:ext>
            </a:extLst>
          </p:cNvPr>
          <p:cNvSpPr txBox="1"/>
          <p:nvPr/>
        </p:nvSpPr>
        <p:spPr>
          <a:xfrm>
            <a:off x="2418531" y="1775227"/>
            <a:ext cx="1335127" cy="71558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kern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defRPr>
            </a:lvl1pPr>
          </a:lstStyle>
          <a:p>
            <a:pPr algn="ctr"/>
            <a:r>
              <a:rPr lang="en-US" altLang="zh-CN" sz="1350" dirty="0"/>
              <a:t>Sacrifice 6 mice in each group</a:t>
            </a:r>
          </a:p>
          <a:p>
            <a:pPr algn="ctr"/>
            <a:r>
              <a:rPr lang="en-US" altLang="zh-CN" sz="1350" dirty="0"/>
              <a:t>(5 groups)</a:t>
            </a:r>
            <a:endParaRPr lang="zh-CN" altLang="en-US" sz="1350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ED838C65-CF37-44A5-A235-D38750004AF4}"/>
              </a:ext>
            </a:extLst>
          </p:cNvPr>
          <p:cNvSpPr txBox="1"/>
          <p:nvPr/>
        </p:nvSpPr>
        <p:spPr>
          <a:xfrm>
            <a:off x="3919028" y="1778483"/>
            <a:ext cx="1335127" cy="71558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kern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defRPr>
            </a:lvl1pPr>
          </a:lstStyle>
          <a:p>
            <a:pPr algn="ctr"/>
            <a:r>
              <a:rPr lang="en-US" altLang="zh-CN" sz="1350" dirty="0"/>
              <a:t>Sacrifice 8 mice in each group</a:t>
            </a:r>
          </a:p>
          <a:p>
            <a:pPr algn="ctr"/>
            <a:r>
              <a:rPr lang="en-US" altLang="zh-CN" sz="1350" dirty="0"/>
              <a:t> (5 groups)</a:t>
            </a:r>
            <a:endParaRPr lang="zh-CN" altLang="en-US" sz="1350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91C7023C-3A84-4B22-A4BB-EE831B5FE96E}"/>
              </a:ext>
            </a:extLst>
          </p:cNvPr>
          <p:cNvSpPr txBox="1"/>
          <p:nvPr/>
        </p:nvSpPr>
        <p:spPr>
          <a:xfrm>
            <a:off x="5500988" y="1783959"/>
            <a:ext cx="1425110" cy="71558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kern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defRPr>
            </a:lvl1pPr>
          </a:lstStyle>
          <a:p>
            <a:pPr algn="ctr"/>
            <a:r>
              <a:rPr lang="en-US" altLang="zh-CN" sz="1350" dirty="0"/>
              <a:t>Sacrifice 10 mice in each group </a:t>
            </a:r>
          </a:p>
          <a:p>
            <a:pPr algn="ctr"/>
            <a:r>
              <a:rPr lang="en-US" altLang="zh-CN" sz="1350" dirty="0"/>
              <a:t>(5 groups)</a:t>
            </a:r>
            <a:endParaRPr lang="zh-CN" altLang="en-US" sz="1350" dirty="0"/>
          </a:p>
        </p:txBody>
      </p: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25117AE8-439B-43EC-8722-C517D6498213}"/>
              </a:ext>
            </a:extLst>
          </p:cNvPr>
          <p:cNvGrpSpPr/>
          <p:nvPr/>
        </p:nvGrpSpPr>
        <p:grpSpPr>
          <a:xfrm>
            <a:off x="1335121" y="2991254"/>
            <a:ext cx="1626951" cy="302774"/>
            <a:chOff x="1780161" y="2845339"/>
            <a:chExt cx="2169268" cy="403698"/>
          </a:xfrm>
        </p:grpSpPr>
        <p:cxnSp>
          <p:nvCxnSpPr>
            <p:cNvPr id="5" name="直接连接符 4">
              <a:extLst>
                <a:ext uri="{FF2B5EF4-FFF2-40B4-BE49-F238E27FC236}">
                  <a16:creationId xmlns:a16="http://schemas.microsoft.com/office/drawing/2014/main" id="{0408239E-7BD1-4104-A6D0-3203662341FF}"/>
                </a:ext>
              </a:extLst>
            </p:cNvPr>
            <p:cNvCxnSpPr>
              <a:cxnSpLocks/>
            </p:cNvCxnSpPr>
            <p:nvPr/>
          </p:nvCxnSpPr>
          <p:spPr>
            <a:xfrm>
              <a:off x="1780161" y="3025302"/>
              <a:ext cx="2169268" cy="0"/>
            </a:xfrm>
            <a:prstGeom prst="line">
              <a:avLst/>
            </a:prstGeom>
            <a:ln w="5715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8" name="直接连接符 7">
              <a:extLst>
                <a:ext uri="{FF2B5EF4-FFF2-40B4-BE49-F238E27FC236}">
                  <a16:creationId xmlns:a16="http://schemas.microsoft.com/office/drawing/2014/main" id="{E2D68CD1-007C-477C-9A20-95459D1D15D0}"/>
                </a:ext>
              </a:extLst>
            </p:cNvPr>
            <p:cNvCxnSpPr>
              <a:cxnSpLocks/>
            </p:cNvCxnSpPr>
            <p:nvPr/>
          </p:nvCxnSpPr>
          <p:spPr>
            <a:xfrm>
              <a:off x="1780161" y="2845339"/>
              <a:ext cx="0" cy="403698"/>
            </a:xfrm>
            <a:prstGeom prst="line">
              <a:avLst/>
            </a:prstGeom>
            <a:ln w="5715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直接连接符 9">
              <a:extLst>
                <a:ext uri="{FF2B5EF4-FFF2-40B4-BE49-F238E27FC236}">
                  <a16:creationId xmlns:a16="http://schemas.microsoft.com/office/drawing/2014/main" id="{F06CAB4C-221F-445B-8363-EEC7CC93D4A6}"/>
                </a:ext>
              </a:extLst>
            </p:cNvPr>
            <p:cNvCxnSpPr>
              <a:cxnSpLocks/>
            </p:cNvCxnSpPr>
            <p:nvPr/>
          </p:nvCxnSpPr>
          <p:spPr>
            <a:xfrm>
              <a:off x="3949429" y="2845339"/>
              <a:ext cx="0" cy="403698"/>
            </a:xfrm>
            <a:prstGeom prst="line">
              <a:avLst/>
            </a:prstGeom>
            <a:ln w="5715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64794E3C-126F-4D1D-88FE-8302301380B4}"/>
              </a:ext>
            </a:extLst>
          </p:cNvPr>
          <p:cNvGrpSpPr/>
          <p:nvPr/>
        </p:nvGrpSpPr>
        <p:grpSpPr>
          <a:xfrm>
            <a:off x="2959641" y="2991254"/>
            <a:ext cx="1626951" cy="302774"/>
            <a:chOff x="1780161" y="2845339"/>
            <a:chExt cx="2169268" cy="403698"/>
          </a:xfrm>
        </p:grpSpPr>
        <p:cxnSp>
          <p:nvCxnSpPr>
            <p:cNvPr id="13" name="直接连接符 12">
              <a:extLst>
                <a:ext uri="{FF2B5EF4-FFF2-40B4-BE49-F238E27FC236}">
                  <a16:creationId xmlns:a16="http://schemas.microsoft.com/office/drawing/2014/main" id="{326EBB75-37CE-4376-9798-BEC2B36457A2}"/>
                </a:ext>
              </a:extLst>
            </p:cNvPr>
            <p:cNvCxnSpPr>
              <a:cxnSpLocks/>
            </p:cNvCxnSpPr>
            <p:nvPr/>
          </p:nvCxnSpPr>
          <p:spPr>
            <a:xfrm>
              <a:off x="1780161" y="3025302"/>
              <a:ext cx="2169268" cy="0"/>
            </a:xfrm>
            <a:prstGeom prst="line">
              <a:avLst/>
            </a:prstGeom>
            <a:ln w="5715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直接连接符 13">
              <a:extLst>
                <a:ext uri="{FF2B5EF4-FFF2-40B4-BE49-F238E27FC236}">
                  <a16:creationId xmlns:a16="http://schemas.microsoft.com/office/drawing/2014/main" id="{F993CCA9-B0D4-4D0D-8309-13F8B9BFFF99}"/>
                </a:ext>
              </a:extLst>
            </p:cNvPr>
            <p:cNvCxnSpPr>
              <a:cxnSpLocks/>
            </p:cNvCxnSpPr>
            <p:nvPr/>
          </p:nvCxnSpPr>
          <p:spPr>
            <a:xfrm>
              <a:off x="1780161" y="2845339"/>
              <a:ext cx="0" cy="403698"/>
            </a:xfrm>
            <a:prstGeom prst="line">
              <a:avLst/>
            </a:prstGeom>
            <a:ln w="5715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直接连接符 14">
              <a:extLst>
                <a:ext uri="{FF2B5EF4-FFF2-40B4-BE49-F238E27FC236}">
                  <a16:creationId xmlns:a16="http://schemas.microsoft.com/office/drawing/2014/main" id="{0DF997DC-793F-4336-B455-E303F83C7F05}"/>
                </a:ext>
              </a:extLst>
            </p:cNvPr>
            <p:cNvCxnSpPr>
              <a:cxnSpLocks/>
            </p:cNvCxnSpPr>
            <p:nvPr/>
          </p:nvCxnSpPr>
          <p:spPr>
            <a:xfrm>
              <a:off x="3949429" y="2845339"/>
              <a:ext cx="0" cy="403698"/>
            </a:xfrm>
            <a:prstGeom prst="line">
              <a:avLst/>
            </a:prstGeom>
            <a:ln w="5715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5375AE6B-DCCF-4AFE-AFD5-C99F22EC9222}"/>
              </a:ext>
            </a:extLst>
          </p:cNvPr>
          <p:cNvGrpSpPr/>
          <p:nvPr/>
        </p:nvGrpSpPr>
        <p:grpSpPr>
          <a:xfrm>
            <a:off x="4586592" y="2991254"/>
            <a:ext cx="1626951" cy="302774"/>
            <a:chOff x="1780161" y="2845339"/>
            <a:chExt cx="2169268" cy="403698"/>
          </a:xfrm>
        </p:grpSpPr>
        <p:cxnSp>
          <p:nvCxnSpPr>
            <p:cNvPr id="17" name="直接连接符 16">
              <a:extLst>
                <a:ext uri="{FF2B5EF4-FFF2-40B4-BE49-F238E27FC236}">
                  <a16:creationId xmlns:a16="http://schemas.microsoft.com/office/drawing/2014/main" id="{40936C88-79DE-407E-A681-961795CDA0B5}"/>
                </a:ext>
              </a:extLst>
            </p:cNvPr>
            <p:cNvCxnSpPr>
              <a:cxnSpLocks/>
            </p:cNvCxnSpPr>
            <p:nvPr/>
          </p:nvCxnSpPr>
          <p:spPr>
            <a:xfrm>
              <a:off x="1780161" y="3025302"/>
              <a:ext cx="2169268" cy="0"/>
            </a:xfrm>
            <a:prstGeom prst="line">
              <a:avLst/>
            </a:prstGeom>
            <a:ln w="5715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直接连接符 17">
              <a:extLst>
                <a:ext uri="{FF2B5EF4-FFF2-40B4-BE49-F238E27FC236}">
                  <a16:creationId xmlns:a16="http://schemas.microsoft.com/office/drawing/2014/main" id="{BD29CCC4-C387-4353-A39E-F308B91AEEB3}"/>
                </a:ext>
              </a:extLst>
            </p:cNvPr>
            <p:cNvCxnSpPr>
              <a:cxnSpLocks/>
            </p:cNvCxnSpPr>
            <p:nvPr/>
          </p:nvCxnSpPr>
          <p:spPr>
            <a:xfrm>
              <a:off x="1780161" y="2845339"/>
              <a:ext cx="0" cy="403698"/>
            </a:xfrm>
            <a:prstGeom prst="line">
              <a:avLst/>
            </a:prstGeom>
            <a:ln w="5715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直接连接符 18">
              <a:extLst>
                <a:ext uri="{FF2B5EF4-FFF2-40B4-BE49-F238E27FC236}">
                  <a16:creationId xmlns:a16="http://schemas.microsoft.com/office/drawing/2014/main" id="{F1DC7D8B-AD44-4321-BBC2-3BE171A300E7}"/>
                </a:ext>
              </a:extLst>
            </p:cNvPr>
            <p:cNvCxnSpPr>
              <a:cxnSpLocks/>
            </p:cNvCxnSpPr>
            <p:nvPr/>
          </p:nvCxnSpPr>
          <p:spPr>
            <a:xfrm>
              <a:off x="3949429" y="2845339"/>
              <a:ext cx="0" cy="403698"/>
            </a:xfrm>
            <a:prstGeom prst="line">
              <a:avLst/>
            </a:prstGeom>
            <a:ln w="5715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B1675D74-B295-47FF-8EB0-8F21DE9DB6A3}"/>
              </a:ext>
            </a:extLst>
          </p:cNvPr>
          <p:cNvCxnSpPr>
            <a:cxnSpLocks/>
          </p:cNvCxnSpPr>
          <p:nvPr/>
        </p:nvCxnSpPr>
        <p:spPr>
          <a:xfrm>
            <a:off x="1526024" y="2991254"/>
            <a:ext cx="0" cy="302774"/>
          </a:xfrm>
          <a:prstGeom prst="line">
            <a:avLst/>
          </a:prstGeom>
          <a:ln w="571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E0784C80-0874-449C-AF85-EC8C19C56802}"/>
              </a:ext>
            </a:extLst>
          </p:cNvPr>
          <p:cNvSpPr txBox="1"/>
          <p:nvPr/>
        </p:nvSpPr>
        <p:spPr>
          <a:xfrm>
            <a:off x="1367951" y="3425233"/>
            <a:ext cx="55447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1</a:t>
            </a:r>
            <a:endParaRPr lang="zh-CN" altLang="en-US" sz="13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98F7F4CC-9F48-40C1-9C8A-23EC06092EA3}"/>
              </a:ext>
            </a:extLst>
          </p:cNvPr>
          <p:cNvSpPr txBox="1"/>
          <p:nvPr/>
        </p:nvSpPr>
        <p:spPr>
          <a:xfrm>
            <a:off x="1109562" y="4179028"/>
            <a:ext cx="932640" cy="71558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kern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defRPr>
            </a:lvl1pPr>
          </a:lstStyle>
          <a:p>
            <a:pPr algn="ctr"/>
            <a:r>
              <a:rPr lang="en-US" altLang="zh-CN" sz="1350" dirty="0" err="1"/>
              <a:t>ig</a:t>
            </a:r>
            <a:r>
              <a:rPr lang="en-US" altLang="zh-CN" sz="1350" dirty="0"/>
              <a:t>.</a:t>
            </a:r>
          </a:p>
          <a:p>
            <a:pPr algn="ctr"/>
            <a:r>
              <a:rPr lang="en-US" altLang="zh-CN" sz="1350" dirty="0"/>
              <a:t>SH/PA/NS.</a:t>
            </a:r>
            <a:endParaRPr lang="zh-CN" altLang="en-US" sz="1350" dirty="0"/>
          </a:p>
        </p:txBody>
      </p:sp>
      <p:sp>
        <p:nvSpPr>
          <p:cNvPr id="37" name="箭头: 下 36">
            <a:extLst>
              <a:ext uri="{FF2B5EF4-FFF2-40B4-BE49-F238E27FC236}">
                <a16:creationId xmlns:a16="http://schemas.microsoft.com/office/drawing/2014/main" id="{50F6F414-CD5D-498A-A4AB-8B1D18559401}"/>
              </a:ext>
            </a:extLst>
          </p:cNvPr>
          <p:cNvSpPr/>
          <p:nvPr/>
        </p:nvSpPr>
        <p:spPr>
          <a:xfrm rot="10800000">
            <a:off x="1506579" y="3761644"/>
            <a:ext cx="138607" cy="284534"/>
          </a:xfrm>
          <a:prstGeom prst="downArrow">
            <a:avLst/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9A0275CF-2F1B-481E-A785-B8E72C60DDE6}"/>
              </a:ext>
            </a:extLst>
          </p:cNvPr>
          <p:cNvSpPr txBox="1"/>
          <p:nvPr/>
        </p:nvSpPr>
        <p:spPr>
          <a:xfrm>
            <a:off x="1475656" y="6021288"/>
            <a:ext cx="4572000" cy="3740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6:</a:t>
            </a:r>
            <a:r>
              <a:rPr lang="en-US" altLang="zh-CN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imal flowchart</a:t>
            </a:r>
            <a:endParaRPr lang="zh-CN" altLang="zh-CN" sz="16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66083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13</Words>
  <Application>Microsoft Office PowerPoint</Application>
  <PresentationFormat>全屏显示(4:3)</PresentationFormat>
  <Paragraphs>26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2" baseType="lpstr"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zhu dewei</cp:lastModifiedBy>
  <cp:revision>3</cp:revision>
  <dcterms:created xsi:type="dcterms:W3CDTF">2020-07-26T14:48:24Z</dcterms:created>
  <dcterms:modified xsi:type="dcterms:W3CDTF">2020-12-18T10:30:55Z</dcterms:modified>
</cp:coreProperties>
</file>